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00" d="100"/>
          <a:sy n="100" d="100"/>
        </p:scale>
        <p:origin x="-834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11013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95680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7171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41532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6633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9909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3057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5258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0188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9940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03394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32A1EB-FC7E-4F92-8194-AB3FA14A42F7}" type="datetimeFigureOut">
              <a:rPr lang="en-IN" smtClean="0"/>
              <a:t>23-0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CE25A-B5DA-491E-95F9-8EE8EACC67D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7659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extBox 2"/>
          <p:cNvSpPr txBox="1">
            <a:spLocks noChangeArrowheads="1"/>
          </p:cNvSpPr>
          <p:nvPr/>
        </p:nvSpPr>
        <p:spPr bwMode="auto">
          <a:xfrm>
            <a:off x="1674814" y="0"/>
            <a:ext cx="23320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r>
              <a:rPr lang="en-US" altLang="ko-KR">
                <a:ea typeface="Malgun Gothic" panose="020B0503020000020004" pitchFamily="34" charset="-127"/>
              </a:rPr>
              <a:t>Supplementary Table 3</a:t>
            </a:r>
          </a:p>
        </p:txBody>
      </p:sp>
      <p:graphicFrame>
        <p:nvGraphicFramePr>
          <p:cNvPr id="5" name="표 4"/>
          <p:cNvGraphicFramePr>
            <a:graphicFrameLocks noGrp="1"/>
          </p:cNvGraphicFramePr>
          <p:nvPr/>
        </p:nvGraphicFramePr>
        <p:xfrm>
          <a:off x="4430714" y="53975"/>
          <a:ext cx="4789487" cy="6696106"/>
        </p:xfrm>
        <a:graphic>
          <a:graphicData uri="http://schemas.openxmlformats.org/drawingml/2006/table">
            <a:tbl>
              <a:tblPr/>
              <a:tblGrid>
                <a:gridCol w="881062"/>
                <a:gridCol w="1274763"/>
                <a:gridCol w="2633662"/>
              </a:tblGrid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</a:rPr>
                        <a:t>Methods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Gene name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Primer sequences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</a:rPr>
                        <a:t>RT-PCR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CXCL3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CACCCAGACAGAAGTCATA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ACTTGCCGCTCTTCAGTAT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CXCL5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AGAAGGAGGTCTGTCTGGA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TGCATTCCGCTTAGCTTT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CXCL5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CAGGGAAGACAAGAAGGAAAGA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AAAGTGAGGAATCCAGGAAGA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CXCL9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TTCGAGGAACCCTAGTGATAA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TTTGAGGTCTTTGAGGGATTT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CXCL9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CCACCCGAACGTCTTATCTAAT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TGGGTCACAGACTCTCAAA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CXCL10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GCCATAGGGAAGCTTGAAA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AGACATCTCTGCTCATCATTC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CXCL11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CTGCTCAAGGCTTCCTTAT-3' 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CTTTCTCGATCTCTGCCATT-3' 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CXCL11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AGGGAAATTCCTGTGCCATAA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CTCTTCTTGGAAGGAGTAGAAA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IL-4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TTGAGAGAGATCATCGGCATTT-3' 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TCACTCTCTGTGGTGTTCTT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IL-4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TTCTACAGCCACCATGAGAA-3' 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CGTTTCAGGAATCGGATCA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IL-6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CTTCCATCCAGTTGCCTTCT-3' 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TCCGACTTGTGAAGTGGTATAG-3' 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IL-6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GAGACTTGCCTGGTGAAA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TGGCTTGTTCCTCACTACT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IL-10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TTGAATTCCCTGGGTGAGAA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TCCACTGCCTTGCTCTTATT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IL-10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TTTCCCTGACCTCCCTCTAA-3' 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GAGACACTGGAAGGTGAATTA-3' 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IL-13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CAGCATGGTATGGAGTG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TATCCTCTGGGTCCTGTAGATG-3' 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C/EBP</a:t>
                      </a: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MS PGothic" panose="020B0600070205080204" pitchFamily="34" charset="-128"/>
                        </a:rPr>
                        <a:t>b</a:t>
                      </a: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ACTTCCTCTCCGACCTCT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AGGCTCACGTAACCGTAG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C/EBP</a:t>
                      </a: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MS PGothic" panose="020B0600070205080204" pitchFamily="34" charset="-128"/>
                        </a:rPr>
                        <a:t>b</a:t>
                      </a: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CGCGACAAGGCCAAGA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CTGCTCCACCTTCTTCT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GCSF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AAGATATTCGAGCAGGGTCTA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TTGTGTTTCACAGTCCGTTT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TNF</a:t>
                      </a: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MS PGothic" panose="020B0600070205080204" pitchFamily="34" charset="-128"/>
                        </a:rPr>
                        <a:t>a</a:t>
                      </a: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TTGTCTACTCCCAGGTTCTC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AGGTTGACTTTCTCCTGGTAT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RPL13a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AGGTCGGGTGGAAGTACCA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TGCATCTTGGCCTTTTCCT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RPL13a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CGAAGATGGCGGAGGTGCA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</a:rPr>
                        <a:t> 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 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GTTTTGTGGGGCAGCATA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79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</a:rPr>
                        <a:t>Reporter construction &amp; ChIP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C/EBP</a:t>
                      </a: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MS PGothic" panose="020B0600070205080204" pitchFamily="34" charset="-128"/>
                        </a:rPr>
                        <a:t>b</a:t>
                      </a: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 3'UTR region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ATACTAGTGCTGCTCCACCTTC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ATAAGCTTTGGTTACAAAGCCTTTTG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ouse C/EBP</a:t>
                      </a: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Symbol" panose="05050102010706020507" pitchFamily="18" charset="2"/>
                          <a:ea typeface="MS PGothic" panose="020B0600070205080204" pitchFamily="34" charset="-128"/>
                        </a:rPr>
                        <a:t>b </a:t>
                      </a: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3'UTR region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ATACTAGTAGCTGCTCCACCTTCTTCT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ATAAGCTTAATGTTTAAAAGCCTTTTGG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IL-4 promoter region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GAGATCTCAACATGGATGAACCTGGAG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GAAGCTTAGCATCACCAGAACATCTG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IL-6 promoter region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AGAACTGAGATCTTTGGAG-3'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GGAAGCTTCGATAAAACAGTGACCTCTG-3'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CXCL9 promoter region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AAATAAGCTTCTATCTTAGCC-3'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CAAGCTTGTATTGGATTTTGAGCCTGAG-3'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IL-4 Chip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CTCTCCCTTCTATGCAAAG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AGGTGTCGATTTGCAGTGA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IL-6 Chip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AGATGCAAAGGAAGGAAG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TGGTGTCTTGCCTATGAAG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Human CXCL9 Chip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Forward primer 5'-GGGTTGGTTCCATGATTTTG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</a:rPr>
                        <a:t> 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 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ACTAATGATCAGGGAAATGC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</a:rPr>
                        <a:t>miR-155 genotyping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 oIMR7859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Wild Forward primer 5'-GTGCTGCAAACCAGGAAG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altLang="en-US" sz="6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PGothic" panose="020B0600070205080204" pitchFamily="34" charset="-128"/>
                      </a:endParaRP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oIMR7860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Reverse primer 5'-CTGGTTGAATCATTGAAGATG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06363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PGothic" panose="020B0600070205080204" pitchFamily="34" charset="-128"/>
                        </a:rPr>
                        <a:t> 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oIMR7861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5pPr>
                      <a:lvl6pPr marL="25146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6pPr>
                      <a:lvl7pPr marL="29718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7pPr>
                      <a:lvl8pPr marL="34290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8pPr>
                      <a:lvl9pPr marL="3886200" indent="-228600" defTabSz="4572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MS PGothic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6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</a:rPr>
                        <a:t>Mutant Forward primer 5'-CGGCAAACGACTGTCCTGGCCG-3' </a:t>
                      </a:r>
                    </a:p>
                  </a:txBody>
                  <a:tcPr marL="3856" marR="3856" marT="3856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63752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58</Words>
  <Application>Microsoft Office PowerPoint</Application>
  <PresentationFormat>Widescreen</PresentationFormat>
  <Paragraphs>10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Malgun Gothic</vt:lpstr>
      <vt:lpstr>MS PGothic</vt:lpstr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shorekumar Kubendran</dc:creator>
  <cp:lastModifiedBy>Kishorekumar Kubendran</cp:lastModifiedBy>
  <cp:revision>1</cp:revision>
  <dcterms:created xsi:type="dcterms:W3CDTF">2016-01-23T07:08:20Z</dcterms:created>
  <dcterms:modified xsi:type="dcterms:W3CDTF">2016-01-23T07:11:18Z</dcterms:modified>
</cp:coreProperties>
</file>